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44A103-2B71-4C19-85E0-9BE7908A48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BD611-3C54-46A0-B361-0AC69E96BA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96BDE-8CD6-4F7F-A30A-00E900ECD2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05532-B22E-4221-886E-89D5B8AFA0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5C455-60DA-4175-A19F-8EE30895D2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39D2C-1FFB-4B18-B673-BDF2ADAF2B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5805D-6A23-428B-A323-1BB6901E3E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4B8F0-3B25-48A8-AA23-012EFED068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C2BAE-23E4-4C2B-8D91-8B40E79084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CADBB-D124-433E-955F-B40700DA37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F0C35C-B4D8-485E-BDC7-EAF9EF9A38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29BBA4-6E9B-4CFC-9BF2-71CD0B7462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7BDDD6-DFAF-4926-AAF0-C4D083C2B53E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156240" y="0"/>
            <a:ext cx="229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Supplementary Table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017720" y="1263600"/>
          <a:ext cx="4608360" cy="7040520"/>
        </p:xfrm>
        <a:graphic>
          <a:graphicData uri="http://schemas.openxmlformats.org/drawingml/2006/table">
            <a:tbl>
              <a:tblPr/>
              <a:tblGrid>
                <a:gridCol w="1444320"/>
                <a:gridCol w="1452600"/>
                <a:gridCol w="1711440"/>
              </a:tblGrid>
              <a:tr h="45684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ow diet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Harlan diet 2016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igh-fat diet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SDS 829197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684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water fuel energy (kcal/g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 gridSpan="2"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rcentage calories from: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t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rbohydrat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6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 gridSpan="2"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rcentage by weight of: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ude protein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4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.1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ude fat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0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.0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684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ude carbohydrate (available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.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9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 gridSpan="3"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dominant fatty acids: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2:0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4:0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6:0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8:0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8:1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8: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9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8: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196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gredients: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ound wheat, ground corn, wheat, corn gluten meal, vitamins, minerals, amino acids, trace elements, soybean oil, yeast, choline chloride,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ctalbumin, casein, olive oil, soya oil, potato protein, coconut oil, cellulose, minerals, vitamins, amino acids, trace elements, dextrose monohydrate, choline bitartrate, cholesterol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4"/>
          <p:cNvSpPr/>
          <p:nvPr/>
        </p:nvSpPr>
        <p:spPr>
          <a:xfrm>
            <a:off x="950400" y="981000"/>
            <a:ext cx="392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upplementary Table. Composition of chow and high-fat diet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7T14:32:33Z</dcterms:created>
  <dc:creator>Lisa</dc:creator>
  <dc:description/>
  <dc:language>en-US</dc:language>
  <cp:lastModifiedBy>Heather, Lisa C</cp:lastModifiedBy>
  <cp:lastPrinted>2013-09-05T16:33:46Z</cp:lastPrinted>
  <dcterms:modified xsi:type="dcterms:W3CDTF">2013-09-17T11:00:40Z</dcterms:modified>
  <cp:revision>149</cp:revision>
  <dc:subject/>
  <dc:title>Slide 1</dc:title>
</cp:coreProperties>
</file>